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>
        <p:scale>
          <a:sx n="196" d="100"/>
          <a:sy n="196" d="100"/>
        </p:scale>
        <p:origin x="462" y="14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C159B-7670-4260-85EE-EAD5E4FCF6B8}" type="datetimeFigureOut">
              <a:rPr lang="ko-KR" altLang="en-US" smtClean="0"/>
              <a:t>2019-06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901B2-19E7-418A-A912-8529DF128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42690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C159B-7670-4260-85EE-EAD5E4FCF6B8}" type="datetimeFigureOut">
              <a:rPr lang="ko-KR" altLang="en-US" smtClean="0"/>
              <a:t>2019-06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901B2-19E7-418A-A912-8529DF128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9782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C159B-7670-4260-85EE-EAD5E4FCF6B8}" type="datetimeFigureOut">
              <a:rPr lang="ko-KR" altLang="en-US" smtClean="0"/>
              <a:t>2019-06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901B2-19E7-418A-A912-8529DF128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9895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C159B-7670-4260-85EE-EAD5E4FCF6B8}" type="datetimeFigureOut">
              <a:rPr lang="ko-KR" altLang="en-US" smtClean="0"/>
              <a:t>2019-06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901B2-19E7-418A-A912-8529DF128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9128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C159B-7670-4260-85EE-EAD5E4FCF6B8}" type="datetimeFigureOut">
              <a:rPr lang="ko-KR" altLang="en-US" smtClean="0"/>
              <a:t>2019-06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901B2-19E7-418A-A912-8529DF128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244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C159B-7670-4260-85EE-EAD5E4FCF6B8}" type="datetimeFigureOut">
              <a:rPr lang="ko-KR" altLang="en-US" smtClean="0"/>
              <a:t>2019-06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901B2-19E7-418A-A912-8529DF128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48401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C159B-7670-4260-85EE-EAD5E4FCF6B8}" type="datetimeFigureOut">
              <a:rPr lang="ko-KR" altLang="en-US" smtClean="0"/>
              <a:t>2019-06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901B2-19E7-418A-A912-8529DF128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48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C159B-7670-4260-85EE-EAD5E4FCF6B8}" type="datetimeFigureOut">
              <a:rPr lang="ko-KR" altLang="en-US" smtClean="0"/>
              <a:t>2019-06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901B2-19E7-418A-A912-8529DF128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8370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C159B-7670-4260-85EE-EAD5E4FCF6B8}" type="datetimeFigureOut">
              <a:rPr lang="ko-KR" altLang="en-US" smtClean="0"/>
              <a:t>2019-06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901B2-19E7-418A-A912-8529DF128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7797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C159B-7670-4260-85EE-EAD5E4FCF6B8}" type="datetimeFigureOut">
              <a:rPr lang="ko-KR" altLang="en-US" smtClean="0"/>
              <a:t>2019-06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901B2-19E7-418A-A912-8529DF128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53131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C159B-7670-4260-85EE-EAD5E4FCF6B8}" type="datetimeFigureOut">
              <a:rPr lang="ko-KR" altLang="en-US" smtClean="0"/>
              <a:t>2019-06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901B2-19E7-418A-A912-8529DF128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3264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EC159B-7670-4260-85EE-EAD5E4FCF6B8}" type="datetimeFigureOut">
              <a:rPr lang="ko-KR" altLang="en-US" smtClean="0"/>
              <a:t>2019-06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C901B2-19E7-418A-A912-8529DF128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1092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8680" y="2859024"/>
            <a:ext cx="5120640" cy="3425952"/>
          </a:xfrm>
          <a:prstGeom prst="rect">
            <a:avLst/>
          </a:prstGeom>
        </p:spPr>
      </p:pic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8812192"/>
              </p:ext>
            </p:extLst>
          </p:nvPr>
        </p:nvGraphicFramePr>
        <p:xfrm>
          <a:off x="553549" y="980800"/>
          <a:ext cx="5598179" cy="79798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83432">
                  <a:extLst>
                    <a:ext uri="{9D8B030D-6E8A-4147-A177-3AD203B41FA5}">
                      <a16:colId xmlns:a16="http://schemas.microsoft.com/office/drawing/2014/main" val="24676075"/>
                    </a:ext>
                  </a:extLst>
                </a:gridCol>
                <a:gridCol w="637951">
                  <a:extLst>
                    <a:ext uri="{9D8B030D-6E8A-4147-A177-3AD203B41FA5}">
                      <a16:colId xmlns:a16="http://schemas.microsoft.com/office/drawing/2014/main" val="2252402265"/>
                    </a:ext>
                  </a:extLst>
                </a:gridCol>
                <a:gridCol w="1473920">
                  <a:extLst>
                    <a:ext uri="{9D8B030D-6E8A-4147-A177-3AD203B41FA5}">
                      <a16:colId xmlns:a16="http://schemas.microsoft.com/office/drawing/2014/main" val="1717736887"/>
                    </a:ext>
                  </a:extLst>
                </a:gridCol>
                <a:gridCol w="2102876">
                  <a:extLst>
                    <a:ext uri="{9D8B030D-6E8A-4147-A177-3AD203B41FA5}">
                      <a16:colId xmlns:a16="http://schemas.microsoft.com/office/drawing/2014/main" val="837566346"/>
                    </a:ext>
                  </a:extLst>
                </a:gridCol>
              </a:tblGrid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Lis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6136125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ag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' to 3'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911984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mjd6a_QRT_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mjd6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, Probe clonin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GAGTGCTCTACCCCTG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6130021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mjd6a_QRT_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mjd6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GAGTGCTCTACCCCTG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5298003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mjd6a_Probe_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mjd6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clonin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ctagacacacaactagaaac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7043448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mjd6b_QRT_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mjd6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, Probe clonin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TCTGCCAGTGGAAGCTC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9257821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mjd6b_QRT_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mjd6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ATTTCGCAAATTCGATC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0349341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mjd6b_Probe_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mjd6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clonin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TGTTCCCTGCTACAGAAT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1471911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5UTR_F4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tattgtgcgttggggtc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5741208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1_R53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ttctgcaaaggaagtg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4530703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2_F5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cagcaaggtaaccacag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0411587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2_R76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gcaccttcttgatagc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0689798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3_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gagaactgcagatcatgagaa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498931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3_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tccccactggagtagaag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0221678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4_F89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ggactacgtacccgaa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7507641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4_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acgtagattatggggag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1083410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5_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cgcagtttagcctacatc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68376921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5_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gccaaagtcgcacag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3104097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6_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ccaacgtgtcgtacatct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3002952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6_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tggaggtgtaatctgtgg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712402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7_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gtattggctgaactgctg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6768164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7_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ttgattatctcaaccag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5724045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8_F131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taccccgactcgagaaca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7793684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8_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tagtccaaggatgcgc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8679585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9_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ctgtgcagccgactg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3114059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KS3b_E9_R152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cagttcgtcgaagaagga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6633054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10_F161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tcctcaattctcatccc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5158424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10_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tgatgtcgatgttgtatttgat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951783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xon11_F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tcaaacactggggagc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3083481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KS3b_3UTR_R188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tgtggccagtgttttg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5632257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1a_QRT_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1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tcattggacacgtcgat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1973637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1a_QRT_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1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ctgccttcagtttgtc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5035844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x2_probe_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x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clonin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cagctctctggacctgg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4117922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x2_probe_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x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clonin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tccgttgcacaattca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3332812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X1_probe_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X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clonin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cagggtgcaggtatggt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9854376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X1_probe_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X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clonin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acccctgacctagaga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6235513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x6-probe_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x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clonin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AATCAACTCGGGGGAGT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1608085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x6-probe_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x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clonin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CCATCGTAAAACTAGG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94853502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X2_Probe_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x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clonin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aaactgtgggaaactg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6564839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X2_Probe_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x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clonin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acatgtgcagtctgctt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0805208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WIST1_Probe_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WIST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clonin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agaaaatgatgcagga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6954301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WIST1_Probe_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WIST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clonin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gcacgactggtggtaa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17790256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_E4_F890_5’P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RACE, 5’ end </a:t>
                      </a:r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osphorelate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ggactacgtacccgaa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0695564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sk3b_F780F_BamH1</a:t>
                      </a: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loning</a:t>
                      </a: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CGGATCCAATCGAGAACTGCAGATCATG</a:t>
                      </a: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2118550"/>
                  </a:ext>
                </a:extLst>
              </a:tr>
              <a:tr h="177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sk3b_R1768_Nhe1</a:t>
                      </a: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loning</a:t>
                      </a: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GGCTAGCTTGTTGGCTCAGGAGGAGTT</a:t>
                      </a:r>
                    </a:p>
                  </a:txBody>
                  <a:tcPr marL="9091" marR="9091" marT="909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4668941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454691" y="263121"/>
            <a:ext cx="4947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ary table 1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0881337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</TotalTime>
  <Words>378</Words>
  <Application>Microsoft Office PowerPoint</Application>
  <PresentationFormat>화면 슬라이드 쇼(4:3)</PresentationFormat>
  <Paragraphs>17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신 지윤</dc:creator>
  <cp:lastModifiedBy>DW SHIN</cp:lastModifiedBy>
  <cp:revision>3</cp:revision>
  <dcterms:created xsi:type="dcterms:W3CDTF">2019-03-20T05:21:25Z</dcterms:created>
  <dcterms:modified xsi:type="dcterms:W3CDTF">2019-06-03T05:18:12Z</dcterms:modified>
</cp:coreProperties>
</file>